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110" d="100"/>
          <a:sy n="110" d="100"/>
        </p:scale>
        <p:origin x="4292" y="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CF6C45-930B-4ABA-B5FE-90B71437E5CF}" type="datetimeFigureOut">
              <a:rPr lang="de-DE" smtClean="0"/>
              <a:t>26.03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6CE21-5961-452D-970A-4F5DF792FE6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730907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CF6C45-930B-4ABA-B5FE-90B71437E5CF}" type="datetimeFigureOut">
              <a:rPr lang="de-DE" smtClean="0"/>
              <a:t>26.03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6CE21-5961-452D-970A-4F5DF792FE6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884035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CF6C45-930B-4ABA-B5FE-90B71437E5CF}" type="datetimeFigureOut">
              <a:rPr lang="de-DE" smtClean="0"/>
              <a:t>26.03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6CE21-5961-452D-970A-4F5DF792FE6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124259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CF6C45-930B-4ABA-B5FE-90B71437E5CF}" type="datetimeFigureOut">
              <a:rPr lang="de-DE" smtClean="0"/>
              <a:t>26.03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6CE21-5961-452D-970A-4F5DF792FE6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231115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CF6C45-930B-4ABA-B5FE-90B71437E5CF}" type="datetimeFigureOut">
              <a:rPr lang="de-DE" smtClean="0"/>
              <a:t>26.03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6CE21-5961-452D-970A-4F5DF792FE6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763147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CF6C45-930B-4ABA-B5FE-90B71437E5CF}" type="datetimeFigureOut">
              <a:rPr lang="de-DE" smtClean="0"/>
              <a:t>26.03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6CE21-5961-452D-970A-4F5DF792FE6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402412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CF6C45-930B-4ABA-B5FE-90B71437E5CF}" type="datetimeFigureOut">
              <a:rPr lang="de-DE" smtClean="0"/>
              <a:t>26.03.2024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6CE21-5961-452D-970A-4F5DF792FE6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861657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CF6C45-930B-4ABA-B5FE-90B71437E5CF}" type="datetimeFigureOut">
              <a:rPr lang="de-DE" smtClean="0"/>
              <a:t>26.03.2024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6CE21-5961-452D-970A-4F5DF792FE6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199205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CF6C45-930B-4ABA-B5FE-90B71437E5CF}" type="datetimeFigureOut">
              <a:rPr lang="de-DE" smtClean="0"/>
              <a:t>26.03.2024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6CE21-5961-452D-970A-4F5DF792FE6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953002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CF6C45-930B-4ABA-B5FE-90B71437E5CF}" type="datetimeFigureOut">
              <a:rPr lang="de-DE" smtClean="0"/>
              <a:t>26.03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6CE21-5961-452D-970A-4F5DF792FE6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231194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CF6C45-930B-4ABA-B5FE-90B71437E5CF}" type="datetimeFigureOut">
              <a:rPr lang="de-DE" smtClean="0"/>
              <a:t>26.03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6CE21-5961-452D-970A-4F5DF792FE6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770251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CF6C45-930B-4ABA-B5FE-90B71437E5CF}" type="datetimeFigureOut">
              <a:rPr lang="de-DE" smtClean="0"/>
              <a:t>26.03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86CE21-5961-452D-970A-4F5DF792FE6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867585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Grafik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3533" y="365915"/>
            <a:ext cx="6320413" cy="4320000"/>
          </a:xfrm>
          <a:prstGeom prst="rect">
            <a:avLst/>
          </a:prstGeom>
        </p:spPr>
      </p:pic>
      <p:sp>
        <p:nvSpPr>
          <p:cNvPr id="7" name="Textfeld 6"/>
          <p:cNvSpPr txBox="1"/>
          <p:nvPr/>
        </p:nvSpPr>
        <p:spPr>
          <a:xfrm>
            <a:off x="149409" y="237281"/>
            <a:ext cx="3465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Grafik 7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8051" y="4635662"/>
            <a:ext cx="6309949" cy="4320000"/>
          </a:xfrm>
          <a:prstGeom prst="rect">
            <a:avLst/>
          </a:prstGeom>
        </p:spPr>
      </p:pic>
      <p:sp>
        <p:nvSpPr>
          <p:cNvPr id="9" name="Textfeld 8"/>
          <p:cNvSpPr txBox="1"/>
          <p:nvPr/>
        </p:nvSpPr>
        <p:spPr>
          <a:xfrm>
            <a:off x="343533" y="4637833"/>
            <a:ext cx="3465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feld 9"/>
          <p:cNvSpPr txBox="1"/>
          <p:nvPr/>
        </p:nvSpPr>
        <p:spPr>
          <a:xfrm>
            <a:off x="600137" y="8955662"/>
            <a:ext cx="611589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rincipal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omponent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alysis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LM- 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LMSC-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EV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ased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on 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BAQ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ntensities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(A) 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LFQ 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ntensities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(B)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0569847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8164" y="344264"/>
            <a:ext cx="5878822" cy="4326759"/>
          </a:xfrm>
          <a:prstGeom prst="rect">
            <a:avLst/>
          </a:prstGeom>
        </p:spPr>
      </p:pic>
      <p:sp>
        <p:nvSpPr>
          <p:cNvPr id="5" name="Textfeld 4"/>
          <p:cNvSpPr txBox="1"/>
          <p:nvPr/>
        </p:nvSpPr>
        <p:spPr>
          <a:xfrm>
            <a:off x="149409" y="237281"/>
            <a:ext cx="3465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feld 5"/>
          <p:cNvSpPr txBox="1"/>
          <p:nvPr/>
        </p:nvSpPr>
        <p:spPr>
          <a:xfrm>
            <a:off x="343533" y="4637833"/>
            <a:ext cx="3465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feld 6"/>
          <p:cNvSpPr txBox="1"/>
          <p:nvPr/>
        </p:nvSpPr>
        <p:spPr>
          <a:xfrm>
            <a:off x="600137" y="9027451"/>
            <a:ext cx="611589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eatmaps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howing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lustering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LMSC- 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LM-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EV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amples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ased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 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BAQ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ntensities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(C) 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LFQ 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ntensities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(D)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Grafik 7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0103" y="4738253"/>
            <a:ext cx="5796883" cy="422196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393761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50</Words>
  <Application>Microsoft Office PowerPoint</Application>
  <PresentationFormat>A4-Papier (210 x 297 mm)</PresentationFormat>
  <Paragraphs>6</Paragraphs>
  <Slides>2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</vt:lpstr>
      <vt:lpstr>PowerPoint-Präsentation</vt:lpstr>
      <vt:lpstr>PowerPoint-Präsentation</vt:lpstr>
    </vt:vector>
  </TitlesOfParts>
  <Company>Universitätsklinikum Freiburg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Dr. Naresh Polisetti</dc:creator>
  <cp:lastModifiedBy>Dr. Naresh Polisetti</cp:lastModifiedBy>
  <cp:revision>6</cp:revision>
  <dcterms:created xsi:type="dcterms:W3CDTF">2024-03-21T12:52:09Z</dcterms:created>
  <dcterms:modified xsi:type="dcterms:W3CDTF">2024-03-26T16:36:04Z</dcterms:modified>
</cp:coreProperties>
</file>